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ABC3C32-DB45-4274-B916-02B4CD941E28}" type="datetime">
              <a:rPr b="0" lang="ja-JP" sz="1200" spc="-1" strike="noStrike">
                <a:solidFill>
                  <a:srgbClr val="000000"/>
                </a:solidFill>
                <a:latin typeface="Arial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C105DD9-8292-4813-9889-0CDFCD05F20B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D2E8262-3452-4875-BC9B-C99BB7E8AAA0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44437-4583-4990-B564-4638E4CC17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16616-06EC-4057-9BBD-7E09D69C0B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539C1-3221-49FC-B042-B8C1B5B616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E5B88-2D5B-4F1F-872B-52D87408C4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00E14-0248-42E3-83A6-CA109FA900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5A368-126E-4533-9517-92035C932A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4D780-8EDF-4013-A9A5-2FFFFA2597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96DAF-5FCA-4AFD-8C60-4F0BE1D1FA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39577-7781-49B9-95F1-AC78F6CC5D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B63EF-BBF0-4FC1-AE34-10EB8559EA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C7377-39B6-44E5-914F-0037BE995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1A914-5A83-4429-8FA6-80E7D3E14A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CA1021B-3AEE-46CE-9DDA-A25284ECE0B2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95CF6C6-6DE7-4742-9570-0A022774D1C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"/>
          <p:cNvSpPr/>
          <p:nvPr/>
        </p:nvSpPr>
        <p:spPr>
          <a:xfrm>
            <a:off x="838080" y="3594240"/>
            <a:ext cx="582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1: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GTGTACATGTAACATGATAATATGCAGTTTGTGTTTA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ATTAAGGT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正方形/長方形 5"/>
          <p:cNvSpPr/>
          <p:nvPr/>
        </p:nvSpPr>
        <p:spPr>
          <a:xfrm>
            <a:off x="838080" y="3838680"/>
            <a:ext cx="575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3: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GTGTACATGTAACATGATAATATGCAGTTTGTGTTTATCATTAAGGT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正方形/長方形 6"/>
          <p:cNvSpPr/>
          <p:nvPr/>
        </p:nvSpPr>
        <p:spPr>
          <a:xfrm>
            <a:off x="825480" y="4070520"/>
            <a:ext cx="532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5: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GTGTACATGTAACATGATAATATGCAGTTTGTGTTTATCATTAAGGT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正方形/長方形 7"/>
          <p:cNvSpPr/>
          <p:nvPr/>
        </p:nvSpPr>
        <p:spPr>
          <a:xfrm>
            <a:off x="1574640" y="3321000"/>
            <a:ext cx="342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p11249: CATGATAATATGCAGTTTGTGTTT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正方形/長方形 8"/>
          <p:cNvSpPr/>
          <p:nvPr/>
        </p:nvSpPr>
        <p:spPr>
          <a:xfrm>
            <a:off x="2463840" y="3645000"/>
            <a:ext cx="2425680" cy="698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9"/>
          <p:cNvSpPr/>
          <p:nvPr/>
        </p:nvSpPr>
        <p:spPr>
          <a:xfrm>
            <a:off x="1663560" y="838080"/>
            <a:ext cx="1866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1    P3    P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図 10" descr=""/>
          <p:cNvPicPr/>
          <p:nvPr/>
        </p:nvPicPr>
        <p:blipFill>
          <a:blip r:embed="rId1"/>
          <a:stretch/>
        </p:blipFill>
        <p:spPr>
          <a:xfrm>
            <a:off x="1295280" y="1104840"/>
            <a:ext cx="1435320" cy="1376280"/>
          </a:xfrm>
          <a:prstGeom prst="rect">
            <a:avLst/>
          </a:prstGeom>
          <a:ln w="0">
            <a:noFill/>
          </a:ln>
        </p:spPr>
      </p:pic>
      <p:sp>
        <p:nvSpPr>
          <p:cNvPr id="55" name="テキスト ボックス 11"/>
          <p:cNvSpPr/>
          <p:nvPr/>
        </p:nvSpPr>
        <p:spPr>
          <a:xfrm>
            <a:off x="1308240" y="81288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6"/>
          <p:cNvSpPr/>
          <p:nvPr/>
        </p:nvSpPr>
        <p:spPr>
          <a:xfrm>
            <a:off x="698400" y="723960"/>
            <a:ext cx="54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7"/>
          <p:cNvSpPr/>
          <p:nvPr/>
        </p:nvSpPr>
        <p:spPr>
          <a:xfrm>
            <a:off x="635040" y="2959200"/>
            <a:ext cx="54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3"/>
          <p:cNvSpPr/>
          <p:nvPr/>
        </p:nvSpPr>
        <p:spPr>
          <a:xfrm>
            <a:off x="774720" y="5067360"/>
            <a:ext cx="54482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7840" indent="-17784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177840" indent="-17784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177840" indent="-17784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177840" indent="-17784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図 16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3790800" y="1082520"/>
            <a:ext cx="2470320" cy="1403640"/>
          </a:xfrm>
          <a:prstGeom prst="rect">
            <a:avLst/>
          </a:prstGeom>
          <a:ln w="0">
            <a:noFill/>
          </a:ln>
        </p:spPr>
      </p:pic>
      <p:sp>
        <p:nvSpPr>
          <p:cNvPr id="60" name="テキスト ボックス 17"/>
          <p:cNvSpPr/>
          <p:nvPr/>
        </p:nvSpPr>
        <p:spPr>
          <a:xfrm>
            <a:off x="3416400" y="711360"/>
            <a:ext cx="54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1"/>
          <p:cNvSpPr/>
          <p:nvPr/>
        </p:nvSpPr>
        <p:spPr>
          <a:xfrm>
            <a:off x="3772080" y="80028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11"/>
          <p:cNvSpPr/>
          <p:nvPr/>
        </p:nvSpPr>
        <p:spPr>
          <a:xfrm>
            <a:off x="5079960" y="78732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9"/>
          <p:cNvSpPr/>
          <p:nvPr/>
        </p:nvSpPr>
        <p:spPr>
          <a:xfrm>
            <a:off x="4076640" y="825480"/>
            <a:ext cx="93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1  P3 P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9"/>
          <p:cNvSpPr/>
          <p:nvPr/>
        </p:nvSpPr>
        <p:spPr>
          <a:xfrm>
            <a:off x="5384880" y="812880"/>
            <a:ext cx="93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1 P3  P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28T23:41:56Z</dcterms:created>
  <dc:creator>松村 英生</dc:creator>
  <dc:description/>
  <dc:language>en-US</dc:language>
  <cp:lastModifiedBy>松村 英生</cp:lastModifiedBy>
  <dcterms:modified xsi:type="dcterms:W3CDTF">2012-06-21T07:10:11Z</dcterms:modified>
  <cp:revision>11</cp:revision>
  <dc:subject/>
  <dc:title>スライド 1</dc:title>
</cp:coreProperties>
</file>